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46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C962BEF6-B1E2-4E09-960C-116D520BD27F}" v="3" dt="2022-04-24T15:25:49.746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92" autoAdjust="0"/>
    <p:restoredTop sz="94660"/>
  </p:normalViewPr>
  <p:slideViewPr>
    <p:cSldViewPr snapToGrid="0">
      <p:cViewPr varScale="1">
        <p:scale>
          <a:sx n="58" d="100"/>
          <a:sy n="58" d="100"/>
        </p:scale>
        <p:origin x="1171" y="4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oberto Merletti" userId="49473658533eb44f" providerId="LiveId" clId="{C962BEF6-B1E2-4E09-960C-116D520BD27F}"/>
    <pc:docChg chg="custSel addSld delSld modSld">
      <pc:chgData name="Roberto Merletti" userId="49473658533eb44f" providerId="LiveId" clId="{C962BEF6-B1E2-4E09-960C-116D520BD27F}" dt="2022-04-24T15:22:38.827" v="8" actId="47"/>
      <pc:docMkLst>
        <pc:docMk/>
      </pc:docMkLst>
      <pc:sldChg chg="delSp modSp mod">
        <pc:chgData name="Roberto Merletti" userId="49473658533eb44f" providerId="LiveId" clId="{C962BEF6-B1E2-4E09-960C-116D520BD27F}" dt="2022-04-24T14:50:14.342" v="6" actId="478"/>
        <pc:sldMkLst>
          <pc:docMk/>
          <pc:sldMk cId="0" sldId="467"/>
        </pc:sldMkLst>
        <pc:spChg chg="del mod">
          <ac:chgData name="Roberto Merletti" userId="49473658533eb44f" providerId="LiveId" clId="{C962BEF6-B1E2-4E09-960C-116D520BD27F}" dt="2022-04-24T14:50:14.342" v="6" actId="478"/>
          <ac:spMkLst>
            <pc:docMk/>
            <pc:sldMk cId="0" sldId="467"/>
            <ac:spMk id="10" creationId="{592B2CDD-2FF4-4211-962D-3220174FB5D8}"/>
          </ac:spMkLst>
        </pc:spChg>
      </pc:sldChg>
      <pc:sldChg chg="modSp add del mod">
        <pc:chgData name="Roberto Merletti" userId="49473658533eb44f" providerId="LiveId" clId="{C962BEF6-B1E2-4E09-960C-116D520BD27F}" dt="2022-04-24T14:50:03.794" v="4" actId="47"/>
        <pc:sldMkLst>
          <pc:docMk/>
          <pc:sldMk cId="2133355670" sldId="468"/>
        </pc:sldMkLst>
        <pc:picChg chg="mod">
          <ac:chgData name="Roberto Merletti" userId="49473658533eb44f" providerId="LiveId" clId="{C962BEF6-B1E2-4E09-960C-116D520BD27F}" dt="2022-04-24T14:45:59.404" v="3" actId="1076"/>
          <ac:picMkLst>
            <pc:docMk/>
            <pc:sldMk cId="2133355670" sldId="468"/>
            <ac:picMk id="3" creationId="{00000000-0000-0000-0000-000000000000}"/>
          </ac:picMkLst>
        </pc:picChg>
      </pc:sldChg>
      <pc:sldChg chg="add del">
        <pc:chgData name="Roberto Merletti" userId="49473658533eb44f" providerId="LiveId" clId="{C962BEF6-B1E2-4E09-960C-116D520BD27F}" dt="2022-04-24T15:22:38.827" v="8" actId="47"/>
        <pc:sldMkLst>
          <pc:docMk/>
          <pc:sldMk cId="3942916961" sldId="468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F4B6E0-CE09-44C9-91E8-FCAB75338C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E423DF9-C3AD-4F5F-93C7-819B1C2240C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DA2458-4717-43E6-A836-F9B7380A45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0125650-B653-4BDB-82A7-8E9CFFA667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2BFA9B-0CAC-4B24-9F2A-EF32D7D666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742728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477C54-08E6-43BC-AC76-1C59AAD4E8E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2302B57-7A3F-48A3-A3B5-E0C1E053033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F762D9-A325-43B0-84F5-3C13D76B06B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E8F596F-1741-43E3-BC83-5A70CBAAE4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65ED8BC-0E04-49EF-B9C3-8BE387787A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199428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C2D3AE-302D-4535-8D69-2275433010B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7A15B86-78AD-4602-B650-CD651199493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4F9D21D-E96B-4C13-94F4-6780378064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01D50A-F8DD-4D7C-A0FB-C638C6C838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4237DEE-E3C5-4AB6-AB8E-362195D971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261172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BlankBlu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oter Placeholder 5"/>
          <p:cNvSpPr>
            <a:spLocks noGrp="1"/>
          </p:cNvSpPr>
          <p:nvPr>
            <p:ph type="ftr" sz="quarter" idx="10"/>
          </p:nvPr>
        </p:nvSpPr>
        <p:spPr/>
        <p:txBody>
          <a:bodyPr/>
          <a:lstStyle>
            <a:lvl1pPr>
              <a:defRPr u="sng">
                <a:latin typeface="+mn-lt"/>
              </a:defRPr>
            </a:lvl1pPr>
          </a:lstStyle>
          <a:p>
            <a:r>
              <a:rPr lang="en-US" dirty="0"/>
              <a:t>CC-BY-NC-ND Roberto Merletti</a:t>
            </a: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B363E4B2-0888-47DE-8A88-D22F6862BD51}" type="slidenum">
              <a:rPr lang="en-US" smtClean="0"/>
              <a:pPr/>
              <a:t>‹#›</a:t>
            </a:fld>
            <a:r>
              <a:rPr lang="en-US" dirty="0"/>
              <a:t> of 49</a:t>
            </a:r>
          </a:p>
        </p:txBody>
      </p:sp>
      <p:sp>
        <p:nvSpPr>
          <p:cNvPr id="9" name="TextBox 8"/>
          <p:cNvSpPr txBox="1"/>
          <p:nvPr userDrawn="1"/>
        </p:nvSpPr>
        <p:spPr>
          <a:xfrm>
            <a:off x="89210" y="6388071"/>
            <a:ext cx="154630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B363E4B2-0888-47DE-8A88-D22F6862BD51}" type="slidenum">
              <a:rPr lang="en-US" sz="160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pPr marL="0" marR="0" lvl="0" indent="0" algn="l" defTabSz="4572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r>
              <a:rPr lang="en-US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52</a:t>
            </a:r>
          </a:p>
        </p:txBody>
      </p:sp>
    </p:spTree>
    <p:extLst>
      <p:ext uri="{BB962C8B-B14F-4D97-AF65-F5344CB8AC3E}">
        <p14:creationId xmlns:p14="http://schemas.microsoft.com/office/powerpoint/2010/main" val="2315575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9C895E-E6A7-4C5B-B307-D4BBE4924A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96B0A34-BE11-4A4C-8F5A-F45DF722D187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A42F89-D027-48C8-AB3E-3B65C012EA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0B4C6E-CC8C-4228-B7C8-1006E6BA264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63D9AE4-198E-4EE0-844E-9BFC2980C9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329044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E9E4B-8C37-4183-80C3-F6770A73F0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FC37CA-3FD0-4A69-850D-97813FE3F97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5A43330-4915-4E90-A43A-A5555E01F8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1B5D65-36A5-4274-ADAF-01C5BCFF61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26E773-3DF3-4BBD-BFFE-3793DBFFB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120630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FC9D2-AE85-4C7E-8084-020418D34F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F067533-D78B-492D-B5CE-8898DF653BE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4B26BAE-974B-4D9B-BCE1-CF128B4F491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42266F4-93A4-46F4-B3A8-956D2722A2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F157B0E-9B63-4997-8383-6F16D89C9B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B82573B-98AA-4210-99FC-3129F8D921B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972457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D5828EC-1273-4BDF-BE3B-DE221CB560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AE5B5D7-824F-4938-BBB0-D96CB3A932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0D052A2-D586-41C2-8A38-C00AF8C16DE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F104FDC-5402-4ED4-8930-FAC7F446C3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F4C989C6-1351-4013-8C57-4BCEFE3FE9B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98D5A89-5878-4B58-9205-8CFFEF89AB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F359CDA9-C264-44B1-B838-80145B1AB1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42ABA57-5AF6-49E0-AB18-1D849CC731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688984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E6A2A56-7CB3-4F42-BD35-2925BD103F9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6D580EB-9431-4A78-AD9D-EE3FED0287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30F4B82-92C0-488A-BF20-504740F53AF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06C7297-B74F-4DFB-9B64-23B0D67DBE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94923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EC66FF5-7BF1-4987-A81F-0BE04C398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EDAC0D4-DF79-49D7-B631-D47E3BCBEC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4EEC9E3D-1BF1-4FD2-B55C-646BE1823C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17475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740D9C-DFC3-4BB7-A39B-64F57DEB0F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B9BD6AC-3EDF-4DFB-8A39-577BA588A43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77F702E-F4B5-4562-A9CF-2120C92AE8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251B534-AE8A-4BE9-B9AE-EEEA635B61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BCC5351-DDC1-49D9-9087-D8AF273805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D14EB60-294A-4118-9B90-842605CC2B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71487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482A4F-35EA-405F-8761-D64B992C9F8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660B57F3-1DBB-4BC9-880D-CC62FCE4732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ECD1BE5-94F6-49AA-B2AA-7AAF6B2C169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84E1F3-5DA4-4E6F-ABFC-6CB2261BD8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215406-EBF3-477B-B89A-42FB534646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480F5CE-2EFC-4840-AED8-81ECBBA98B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3475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00A67C9-9683-49F9-A14C-88E4FED739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0593D1-F1D9-4468-9658-28C2F8051E9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536D7E-4499-4867-AFBD-3D18DD7E01E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EE1823D-F6A2-451D-9542-314FC2C000AD}" type="datetimeFigureOut">
              <a:rPr lang="en-GB" smtClean="0"/>
              <a:t>24/04/2022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90AB73-3D18-42E3-8448-CF6F1810A538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0F04065-99AC-4C7C-96A8-8B2730860D0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E6BFC81-FFB7-47F3-8D1F-F8E8A7D3B4C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538731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Video2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 rotWithShape="1">
          <a:blip r:embed="rId4"/>
          <a:srcRect l="4564" t="7500" r="2427" b="-3654"/>
          <a:stretch>
            <a:fillRect/>
          </a:stretch>
        </p:blipFill>
        <p:spPr>
          <a:xfrm>
            <a:off x="357952" y="670029"/>
            <a:ext cx="8166923" cy="5182222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503077" y="652152"/>
            <a:ext cx="5095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6321613" y="626822"/>
            <a:ext cx="50958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53865" y="5825478"/>
            <a:ext cx="158591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400" dirty="0">
                <a:latin typeface="Arial" panose="020B0604020202020204" pitchFamily="34" charset="0"/>
                <a:cs typeface="Arial" panose="020B0604020202020204" pitchFamily="34" charset="0"/>
              </a:rPr>
              <a:t>Click here to start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CAB08A26-2285-4504-9743-F7135F6F4546}"/>
              </a:ext>
            </a:extLst>
          </p:cNvPr>
          <p:cNvGrpSpPr/>
          <p:nvPr/>
        </p:nvGrpSpPr>
        <p:grpSpPr>
          <a:xfrm>
            <a:off x="8628962" y="1740252"/>
            <a:ext cx="3089923" cy="2132999"/>
            <a:chOff x="8686801" y="1336513"/>
            <a:chExt cx="3089923" cy="2132999"/>
          </a:xfrm>
        </p:grpSpPr>
        <p:cxnSp>
          <p:nvCxnSpPr>
            <p:cNvPr id="20" name="Straight Connector 19">
              <a:extLst>
                <a:ext uri="{FF2B5EF4-FFF2-40B4-BE49-F238E27FC236}">
                  <a16:creationId xmlns:a16="http://schemas.microsoft.com/office/drawing/2014/main" id="{5F47E512-AB2D-4150-96F1-9266648855A7}"/>
                </a:ext>
              </a:extLst>
            </p:cNvPr>
            <p:cNvCxnSpPr/>
            <p:nvPr/>
          </p:nvCxnSpPr>
          <p:spPr>
            <a:xfrm>
              <a:off x="8686801" y="1538278"/>
              <a:ext cx="400050" cy="0"/>
            </a:xfrm>
            <a:prstGeom prst="line">
              <a:avLst/>
            </a:prstGeom>
            <a:ln w="25400">
              <a:solidFill>
                <a:schemeClr val="bg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>
              <a:extLst>
                <a:ext uri="{FF2B5EF4-FFF2-40B4-BE49-F238E27FC236}">
                  <a16:creationId xmlns:a16="http://schemas.microsoft.com/office/drawing/2014/main" id="{C1E54F0D-9847-4CAF-8BA7-E1636E0CDDEE}"/>
                </a:ext>
              </a:extLst>
            </p:cNvPr>
            <p:cNvCxnSpPr/>
            <p:nvPr/>
          </p:nvCxnSpPr>
          <p:spPr>
            <a:xfrm>
              <a:off x="8686801" y="2038351"/>
              <a:ext cx="400050" cy="0"/>
            </a:xfrm>
            <a:prstGeom prst="line">
              <a:avLst/>
            </a:prstGeom>
            <a:ln w="25400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>
              <a:extLst>
                <a:ext uri="{FF2B5EF4-FFF2-40B4-BE49-F238E27FC236}">
                  <a16:creationId xmlns:a16="http://schemas.microsoft.com/office/drawing/2014/main" id="{30EC7C6D-BA02-4AC4-8129-37CEE6443376}"/>
                </a:ext>
              </a:extLst>
            </p:cNvPr>
            <p:cNvCxnSpPr/>
            <p:nvPr/>
          </p:nvCxnSpPr>
          <p:spPr>
            <a:xfrm>
              <a:off x="8686801" y="2690813"/>
              <a:ext cx="400050" cy="0"/>
            </a:xfrm>
            <a:prstGeom prst="line">
              <a:avLst/>
            </a:prstGeom>
            <a:ln w="25400">
              <a:solidFill>
                <a:srgbClr val="00B05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>
              <a:extLst>
                <a:ext uri="{FF2B5EF4-FFF2-40B4-BE49-F238E27FC236}">
                  <a16:creationId xmlns:a16="http://schemas.microsoft.com/office/drawing/2014/main" id="{1354E830-8270-423A-821A-29CD22842478}"/>
                </a:ext>
              </a:extLst>
            </p:cNvPr>
            <p:cNvCxnSpPr/>
            <p:nvPr/>
          </p:nvCxnSpPr>
          <p:spPr>
            <a:xfrm>
              <a:off x="8686801" y="3286126"/>
              <a:ext cx="40005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1F6B7A82-3CB5-491F-B3AB-233800430D42}"/>
                </a:ext>
              </a:extLst>
            </p:cNvPr>
            <p:cNvSpPr txBox="1"/>
            <p:nvPr/>
          </p:nvSpPr>
          <p:spPr>
            <a:xfrm>
              <a:off x="9329738" y="1336513"/>
              <a:ext cx="244698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solidFill>
                    <a:schemeClr val="bg1">
                      <a:lumMod val="7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lectrode (length L)</a:t>
              </a:r>
            </a:p>
          </p:txBody>
        </p:sp>
        <p:sp>
          <p:nvSpPr>
            <p:cNvPr id="25" name="TextBox 24">
              <a:extLst>
                <a:ext uri="{FF2B5EF4-FFF2-40B4-BE49-F238E27FC236}">
                  <a16:creationId xmlns:a16="http://schemas.microsoft.com/office/drawing/2014/main" id="{C0FB7E9F-B0DA-48EE-BBD7-24DE34C6E5F1}"/>
                </a:ext>
              </a:extLst>
            </p:cNvPr>
            <p:cNvSpPr txBox="1"/>
            <p:nvPr/>
          </p:nvSpPr>
          <p:spPr>
            <a:xfrm flipH="1">
              <a:off x="9280684" y="1815854"/>
              <a:ext cx="230838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solidFill>
                    <a:srgbClr val="FF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Electrode potential</a:t>
              </a:r>
            </a:p>
          </p:txBody>
        </p:sp>
        <p:sp>
          <p:nvSpPr>
            <p:cNvPr id="26" name="TextBox 25">
              <a:extLst>
                <a:ext uri="{FF2B5EF4-FFF2-40B4-BE49-F238E27FC236}">
                  <a16:creationId xmlns:a16="http://schemas.microsoft.com/office/drawing/2014/main" id="{A3B5D5D4-5A72-4217-B045-07CB26A893E5}"/>
                </a:ext>
              </a:extLst>
            </p:cNvPr>
            <p:cNvSpPr txBox="1"/>
            <p:nvPr/>
          </p:nvSpPr>
          <p:spPr>
            <a:xfrm>
              <a:off x="9280684" y="2361516"/>
              <a:ext cx="2319337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solidFill>
                    <a:srgbClr val="00B05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ignal propagating under the electrode</a:t>
              </a:r>
            </a:p>
          </p:txBody>
        </p:sp>
        <p:sp>
          <p:nvSpPr>
            <p:cNvPr id="27" name="TextBox 26">
              <a:extLst>
                <a:ext uri="{FF2B5EF4-FFF2-40B4-BE49-F238E27FC236}">
                  <a16:creationId xmlns:a16="http://schemas.microsoft.com/office/drawing/2014/main" id="{4C040CCB-B21D-40E1-9C6B-3259CD3334E6}"/>
                </a:ext>
              </a:extLst>
            </p:cNvPr>
            <p:cNvSpPr txBox="1"/>
            <p:nvPr/>
          </p:nvSpPr>
          <p:spPr>
            <a:xfrm>
              <a:off x="9231630" y="3100180"/>
              <a:ext cx="2357438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>
                  <a:latin typeface="Arial" panose="020B0604020202020204" pitchFamily="34" charset="0"/>
                  <a:cs typeface="Arial" panose="020B0604020202020204" pitchFamily="34" charset="0"/>
                </a:rPr>
                <a:t>Signal in time</a:t>
              </a:r>
            </a:p>
          </p:txBody>
        </p:sp>
      </p:grpSp>
      <p:sp>
        <p:nvSpPr>
          <p:cNvPr id="28" name="TextBox 27">
            <a:extLst>
              <a:ext uri="{FF2B5EF4-FFF2-40B4-BE49-F238E27FC236}">
                <a16:creationId xmlns:a16="http://schemas.microsoft.com/office/drawing/2014/main" id="{D6FDDE89-420C-4151-A728-599AF325BC99}"/>
              </a:ext>
            </a:extLst>
          </p:cNvPr>
          <p:cNvSpPr txBox="1"/>
          <p:nvPr/>
        </p:nvSpPr>
        <p:spPr>
          <a:xfrm>
            <a:off x="4023677" y="5765839"/>
            <a:ext cx="22606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 err="1"/>
              <a:t>a.u</a:t>
            </a:r>
            <a:r>
              <a:rPr lang="en-GB" dirty="0"/>
              <a:t>. : arbitrary unit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B09542ED-20DF-46DB-9E56-B4230A85EB66}"/>
              </a:ext>
            </a:extLst>
          </p:cNvPr>
          <p:cNvSpPr txBox="1"/>
          <p:nvPr/>
        </p:nvSpPr>
        <p:spPr>
          <a:xfrm>
            <a:off x="2442132" y="958080"/>
            <a:ext cx="1999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Signal in space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F4CCEA1-8149-42C4-8F75-FBC1EB5021B8}"/>
              </a:ext>
            </a:extLst>
          </p:cNvPr>
          <p:cNvSpPr txBox="1"/>
          <p:nvPr/>
        </p:nvSpPr>
        <p:spPr>
          <a:xfrm>
            <a:off x="6466054" y="982238"/>
            <a:ext cx="199928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600" dirty="0">
                <a:latin typeface="Arial" panose="020B0604020202020204" pitchFamily="34" charset="0"/>
                <a:cs typeface="Arial" panose="020B0604020202020204" pitchFamily="34" charset="0"/>
              </a:rPr>
              <a:t>Signal in tim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EF88A81F-60E7-457B-98F7-13F38C4930CC}"/>
              </a:ext>
            </a:extLst>
          </p:cNvPr>
          <p:cNvSpPr txBox="1"/>
          <p:nvPr/>
        </p:nvSpPr>
        <p:spPr>
          <a:xfrm>
            <a:off x="10515600" y="6203950"/>
            <a:ext cx="7970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. 18</a:t>
            </a: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9114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3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3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3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3"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9</Words>
  <Application>Microsoft Office PowerPoint</Application>
  <PresentationFormat>Widescreen</PresentationFormat>
  <Paragraphs>11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oberto Merletti</dc:creator>
  <cp:lastModifiedBy>Roberto Merletti</cp:lastModifiedBy>
  <cp:revision>1</cp:revision>
  <dcterms:created xsi:type="dcterms:W3CDTF">2022-03-09T18:53:49Z</dcterms:created>
  <dcterms:modified xsi:type="dcterms:W3CDTF">2022-04-24T15:25:59Z</dcterms:modified>
</cp:coreProperties>
</file>